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332" r:id="rId5"/>
  </p:sldIdLst>
  <p:sldSz cx="6858000" cy="9906000" type="A4"/>
  <p:notesSz cx="6858000" cy="9144000"/>
  <p:defaultTextStyle>
    <a:defPPr>
      <a:defRPr lang="en-US"/>
    </a:defPPr>
    <a:lvl1pPr marL="0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1pPr>
    <a:lvl2pPr marL="436345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2pPr>
    <a:lvl3pPr marL="872690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3pPr>
    <a:lvl4pPr marL="1309035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4pPr>
    <a:lvl5pPr marL="1745380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5pPr>
    <a:lvl6pPr marL="2181725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6pPr>
    <a:lvl7pPr marL="2618070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7pPr>
    <a:lvl8pPr marL="3054416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8pPr>
    <a:lvl9pPr marL="3490760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rvathy  Harikumar" initials="PH" lastIdx="2" clrIdx="0">
    <p:extLst>
      <p:ext uri="{19B8F6BF-5375-455C-9EA6-DF929625EA0E}">
        <p15:presenceInfo xmlns:p15="http://schemas.microsoft.com/office/powerpoint/2012/main" userId="S::Parvathy.Harikumar@nibsc.org::58811d80-9869-45d1-a9fb-2be9b3ec8b2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8955" autoAdjust="0"/>
    <p:restoredTop sz="94641" autoAdjust="0"/>
  </p:normalViewPr>
  <p:slideViewPr>
    <p:cSldViewPr snapToGrid="0">
      <p:cViewPr varScale="1">
        <p:scale>
          <a:sx n="86" d="100"/>
          <a:sy n="86" d="100"/>
        </p:scale>
        <p:origin x="30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4"/>
            <a:ext cx="5143500" cy="3448756"/>
          </a:xfrm>
        </p:spPr>
        <p:txBody>
          <a:bodyPr anchor="b"/>
          <a:lstStyle>
            <a:lvl1pPr algn="ctr">
              <a:defRPr sz="261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045"/>
            </a:lvl1pPr>
            <a:lvl2pPr marL="199016" indent="0" algn="ctr">
              <a:buNone/>
              <a:defRPr sz="871"/>
            </a:lvl2pPr>
            <a:lvl3pPr marL="398033" indent="0" algn="ctr">
              <a:buNone/>
              <a:defRPr sz="783"/>
            </a:lvl3pPr>
            <a:lvl4pPr marL="597049" indent="0" algn="ctr">
              <a:buNone/>
              <a:defRPr sz="699"/>
            </a:lvl4pPr>
            <a:lvl5pPr marL="796068" indent="0" algn="ctr">
              <a:buNone/>
              <a:defRPr sz="699"/>
            </a:lvl5pPr>
            <a:lvl6pPr marL="995085" indent="0" algn="ctr">
              <a:buNone/>
              <a:defRPr sz="699"/>
            </a:lvl6pPr>
            <a:lvl7pPr marL="1194101" indent="0" algn="ctr">
              <a:buNone/>
              <a:defRPr sz="699"/>
            </a:lvl7pPr>
            <a:lvl8pPr marL="1393117" indent="0" algn="ctr">
              <a:buNone/>
              <a:defRPr sz="699"/>
            </a:lvl8pPr>
            <a:lvl9pPr marL="1592134" indent="0" algn="ctr">
              <a:buNone/>
              <a:defRPr sz="699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05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67962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05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73783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527406"/>
            <a:ext cx="1478755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6"/>
            <a:ext cx="4350545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05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24667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05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037212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8"/>
            <a:ext cx="5915025" cy="4120620"/>
          </a:xfrm>
        </p:spPr>
        <p:txBody>
          <a:bodyPr anchor="b"/>
          <a:lstStyle>
            <a:lvl1pPr>
              <a:defRPr sz="261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9"/>
            <a:ext cx="5915025" cy="2166936"/>
          </a:xfrm>
        </p:spPr>
        <p:txBody>
          <a:bodyPr/>
          <a:lstStyle>
            <a:lvl1pPr marL="0" indent="0">
              <a:buNone/>
              <a:defRPr sz="1045">
                <a:solidFill>
                  <a:schemeClr val="tx1">
                    <a:tint val="75000"/>
                  </a:schemeClr>
                </a:solidFill>
              </a:defRPr>
            </a:lvl1pPr>
            <a:lvl2pPr marL="199016" indent="0">
              <a:buNone/>
              <a:defRPr sz="871">
                <a:solidFill>
                  <a:schemeClr val="tx1">
                    <a:tint val="75000"/>
                  </a:schemeClr>
                </a:solidFill>
              </a:defRPr>
            </a:lvl2pPr>
            <a:lvl3pPr marL="398033" indent="0">
              <a:buNone/>
              <a:defRPr sz="783">
                <a:solidFill>
                  <a:schemeClr val="tx1">
                    <a:tint val="75000"/>
                  </a:schemeClr>
                </a:solidFill>
              </a:defRPr>
            </a:lvl3pPr>
            <a:lvl4pPr marL="597049" indent="0">
              <a:buNone/>
              <a:defRPr sz="699">
                <a:solidFill>
                  <a:schemeClr val="tx1">
                    <a:tint val="75000"/>
                  </a:schemeClr>
                </a:solidFill>
              </a:defRPr>
            </a:lvl4pPr>
            <a:lvl5pPr marL="796068" indent="0">
              <a:buNone/>
              <a:defRPr sz="699">
                <a:solidFill>
                  <a:schemeClr val="tx1">
                    <a:tint val="75000"/>
                  </a:schemeClr>
                </a:solidFill>
              </a:defRPr>
            </a:lvl5pPr>
            <a:lvl6pPr marL="995085" indent="0">
              <a:buNone/>
              <a:defRPr sz="699">
                <a:solidFill>
                  <a:schemeClr val="tx1">
                    <a:tint val="75000"/>
                  </a:schemeClr>
                </a:solidFill>
              </a:defRPr>
            </a:lvl6pPr>
            <a:lvl7pPr marL="1194101" indent="0">
              <a:buNone/>
              <a:defRPr sz="699">
                <a:solidFill>
                  <a:schemeClr val="tx1">
                    <a:tint val="75000"/>
                  </a:schemeClr>
                </a:solidFill>
              </a:defRPr>
            </a:lvl7pPr>
            <a:lvl8pPr marL="1393117" indent="0">
              <a:buNone/>
              <a:defRPr sz="699">
                <a:solidFill>
                  <a:schemeClr val="tx1">
                    <a:tint val="75000"/>
                  </a:schemeClr>
                </a:solidFill>
              </a:defRPr>
            </a:lvl8pPr>
            <a:lvl9pPr marL="1592134" indent="0">
              <a:buNone/>
              <a:defRPr sz="6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05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21138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05/06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10372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8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4" y="2428352"/>
            <a:ext cx="2901255" cy="1190095"/>
          </a:xfrm>
        </p:spPr>
        <p:txBody>
          <a:bodyPr anchor="b"/>
          <a:lstStyle>
            <a:lvl1pPr marL="0" indent="0">
              <a:buNone/>
              <a:defRPr sz="1045" b="1"/>
            </a:lvl1pPr>
            <a:lvl2pPr marL="199016" indent="0">
              <a:buNone/>
              <a:defRPr sz="871" b="1"/>
            </a:lvl2pPr>
            <a:lvl3pPr marL="398033" indent="0">
              <a:buNone/>
              <a:defRPr sz="783" b="1"/>
            </a:lvl3pPr>
            <a:lvl4pPr marL="597049" indent="0">
              <a:buNone/>
              <a:defRPr sz="699" b="1"/>
            </a:lvl4pPr>
            <a:lvl5pPr marL="796068" indent="0">
              <a:buNone/>
              <a:defRPr sz="699" b="1"/>
            </a:lvl5pPr>
            <a:lvl6pPr marL="995085" indent="0">
              <a:buNone/>
              <a:defRPr sz="699" b="1"/>
            </a:lvl6pPr>
            <a:lvl7pPr marL="1194101" indent="0">
              <a:buNone/>
              <a:defRPr sz="699" b="1"/>
            </a:lvl7pPr>
            <a:lvl8pPr marL="1393117" indent="0">
              <a:buNone/>
              <a:defRPr sz="699" b="1"/>
            </a:lvl8pPr>
            <a:lvl9pPr marL="1592134" indent="0">
              <a:buNone/>
              <a:defRPr sz="69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4" y="3618444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6" y="2428352"/>
            <a:ext cx="2915543" cy="1190095"/>
          </a:xfrm>
        </p:spPr>
        <p:txBody>
          <a:bodyPr anchor="b"/>
          <a:lstStyle>
            <a:lvl1pPr marL="0" indent="0">
              <a:buNone/>
              <a:defRPr sz="1045" b="1"/>
            </a:lvl1pPr>
            <a:lvl2pPr marL="199016" indent="0">
              <a:buNone/>
              <a:defRPr sz="871" b="1"/>
            </a:lvl2pPr>
            <a:lvl3pPr marL="398033" indent="0">
              <a:buNone/>
              <a:defRPr sz="783" b="1"/>
            </a:lvl3pPr>
            <a:lvl4pPr marL="597049" indent="0">
              <a:buNone/>
              <a:defRPr sz="699" b="1"/>
            </a:lvl4pPr>
            <a:lvl5pPr marL="796068" indent="0">
              <a:buNone/>
              <a:defRPr sz="699" b="1"/>
            </a:lvl5pPr>
            <a:lvl6pPr marL="995085" indent="0">
              <a:buNone/>
              <a:defRPr sz="699" b="1"/>
            </a:lvl6pPr>
            <a:lvl7pPr marL="1194101" indent="0">
              <a:buNone/>
              <a:defRPr sz="699" b="1"/>
            </a:lvl7pPr>
            <a:lvl8pPr marL="1393117" indent="0">
              <a:buNone/>
              <a:defRPr sz="699" b="1"/>
            </a:lvl8pPr>
            <a:lvl9pPr marL="1592134" indent="0">
              <a:buNone/>
              <a:defRPr sz="69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6" y="3618444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05/06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57471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05/06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89904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05/06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80412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139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426287"/>
            <a:ext cx="3471863" cy="7039681"/>
          </a:xfrm>
        </p:spPr>
        <p:txBody>
          <a:bodyPr/>
          <a:lstStyle>
            <a:lvl1pPr>
              <a:defRPr sz="1392"/>
            </a:lvl1pPr>
            <a:lvl2pPr>
              <a:defRPr sz="1220"/>
            </a:lvl2pPr>
            <a:lvl3pPr>
              <a:defRPr sz="1045"/>
            </a:lvl3pPr>
            <a:lvl4pPr>
              <a:defRPr sz="871"/>
            </a:lvl4pPr>
            <a:lvl5pPr>
              <a:defRPr sz="871"/>
            </a:lvl5pPr>
            <a:lvl6pPr>
              <a:defRPr sz="871"/>
            </a:lvl6pPr>
            <a:lvl7pPr>
              <a:defRPr sz="871"/>
            </a:lvl7pPr>
            <a:lvl8pPr>
              <a:defRPr sz="871"/>
            </a:lvl8pPr>
            <a:lvl9pPr>
              <a:defRPr sz="87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5"/>
            <a:ext cx="2211884" cy="5505627"/>
          </a:xfrm>
        </p:spPr>
        <p:txBody>
          <a:bodyPr/>
          <a:lstStyle>
            <a:lvl1pPr marL="0" indent="0">
              <a:buNone/>
              <a:defRPr sz="699"/>
            </a:lvl1pPr>
            <a:lvl2pPr marL="199016" indent="0">
              <a:buNone/>
              <a:defRPr sz="611"/>
            </a:lvl2pPr>
            <a:lvl3pPr marL="398033" indent="0">
              <a:buNone/>
              <a:defRPr sz="521"/>
            </a:lvl3pPr>
            <a:lvl4pPr marL="597049" indent="0">
              <a:buNone/>
              <a:defRPr sz="437"/>
            </a:lvl4pPr>
            <a:lvl5pPr marL="796068" indent="0">
              <a:buNone/>
              <a:defRPr sz="437"/>
            </a:lvl5pPr>
            <a:lvl6pPr marL="995085" indent="0">
              <a:buNone/>
              <a:defRPr sz="437"/>
            </a:lvl6pPr>
            <a:lvl7pPr marL="1194101" indent="0">
              <a:buNone/>
              <a:defRPr sz="437"/>
            </a:lvl7pPr>
            <a:lvl8pPr marL="1393117" indent="0">
              <a:buNone/>
              <a:defRPr sz="437"/>
            </a:lvl8pPr>
            <a:lvl9pPr marL="1592134" indent="0">
              <a:buNone/>
              <a:defRPr sz="43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05/06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81262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139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6" y="1426287"/>
            <a:ext cx="3471863" cy="7039681"/>
          </a:xfrm>
        </p:spPr>
        <p:txBody>
          <a:bodyPr/>
          <a:lstStyle>
            <a:lvl1pPr marL="0" indent="0">
              <a:buNone/>
              <a:defRPr sz="1392"/>
            </a:lvl1pPr>
            <a:lvl2pPr marL="199016" indent="0">
              <a:buNone/>
              <a:defRPr sz="1220"/>
            </a:lvl2pPr>
            <a:lvl3pPr marL="398033" indent="0">
              <a:buNone/>
              <a:defRPr sz="1045"/>
            </a:lvl3pPr>
            <a:lvl4pPr marL="597049" indent="0">
              <a:buNone/>
              <a:defRPr sz="871"/>
            </a:lvl4pPr>
            <a:lvl5pPr marL="796068" indent="0">
              <a:buNone/>
              <a:defRPr sz="871"/>
            </a:lvl5pPr>
            <a:lvl6pPr marL="995085" indent="0">
              <a:buNone/>
              <a:defRPr sz="871"/>
            </a:lvl6pPr>
            <a:lvl7pPr marL="1194101" indent="0">
              <a:buNone/>
              <a:defRPr sz="871"/>
            </a:lvl7pPr>
            <a:lvl8pPr marL="1393117" indent="0">
              <a:buNone/>
              <a:defRPr sz="871"/>
            </a:lvl8pPr>
            <a:lvl9pPr marL="1592134" indent="0">
              <a:buNone/>
              <a:defRPr sz="871"/>
            </a:lvl9pPr>
          </a:lstStyle>
          <a:p>
            <a:r>
              <a:rPr lang="en-US" dirty="0"/>
              <a:t>Click icon to add picture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5"/>
            <a:ext cx="2211884" cy="5505627"/>
          </a:xfrm>
        </p:spPr>
        <p:txBody>
          <a:bodyPr/>
          <a:lstStyle>
            <a:lvl1pPr marL="0" indent="0">
              <a:buNone/>
              <a:defRPr sz="699"/>
            </a:lvl1pPr>
            <a:lvl2pPr marL="199016" indent="0">
              <a:buNone/>
              <a:defRPr sz="611"/>
            </a:lvl2pPr>
            <a:lvl3pPr marL="398033" indent="0">
              <a:buNone/>
              <a:defRPr sz="521"/>
            </a:lvl3pPr>
            <a:lvl4pPr marL="597049" indent="0">
              <a:buNone/>
              <a:defRPr sz="437"/>
            </a:lvl4pPr>
            <a:lvl5pPr marL="796068" indent="0">
              <a:buNone/>
              <a:defRPr sz="437"/>
            </a:lvl5pPr>
            <a:lvl6pPr marL="995085" indent="0">
              <a:buNone/>
              <a:defRPr sz="437"/>
            </a:lvl6pPr>
            <a:lvl7pPr marL="1194101" indent="0">
              <a:buNone/>
              <a:defRPr sz="437"/>
            </a:lvl7pPr>
            <a:lvl8pPr marL="1393117" indent="0">
              <a:buNone/>
              <a:defRPr sz="437"/>
            </a:lvl8pPr>
            <a:lvl9pPr marL="1592134" indent="0">
              <a:buNone/>
              <a:defRPr sz="43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05/06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07332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8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D5C50-A4F9-4A1F-BD14-862065C97CA3}" type="datetimeFigureOut">
              <a:rPr lang="en-GB" smtClean="0"/>
              <a:t>05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8"/>
            <a:ext cx="2314575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82406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398033" rtl="0" eaLnBrk="1" latinLnBrk="0" hangingPunct="1">
        <a:lnSpc>
          <a:spcPct val="90000"/>
        </a:lnSpc>
        <a:spcBef>
          <a:spcPct val="0"/>
        </a:spcBef>
        <a:buNone/>
        <a:defRPr sz="191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9510" indent="-99510" algn="l" defTabSz="398033" rtl="0" eaLnBrk="1" latinLnBrk="0" hangingPunct="1">
        <a:lnSpc>
          <a:spcPct val="90000"/>
        </a:lnSpc>
        <a:spcBef>
          <a:spcPts val="437"/>
        </a:spcBef>
        <a:buFont typeface="Arial" panose="020B0604020202020204" pitchFamily="34" charset="0"/>
        <a:buChar char="•"/>
        <a:defRPr sz="1220" kern="1200">
          <a:solidFill>
            <a:schemeClr val="tx1"/>
          </a:solidFill>
          <a:latin typeface="+mn-lt"/>
          <a:ea typeface="+mn-ea"/>
          <a:cs typeface="+mn-cs"/>
        </a:defRPr>
      </a:lvl1pPr>
      <a:lvl2pPr marL="298526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1045" kern="1200">
          <a:solidFill>
            <a:schemeClr val="tx1"/>
          </a:solidFill>
          <a:latin typeface="+mn-lt"/>
          <a:ea typeface="+mn-ea"/>
          <a:cs typeface="+mn-cs"/>
        </a:defRPr>
      </a:lvl2pPr>
      <a:lvl3pPr marL="497542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871" kern="1200">
          <a:solidFill>
            <a:schemeClr val="tx1"/>
          </a:solidFill>
          <a:latin typeface="+mn-lt"/>
          <a:ea typeface="+mn-ea"/>
          <a:cs typeface="+mn-cs"/>
        </a:defRPr>
      </a:lvl3pPr>
      <a:lvl4pPr marL="696559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783" kern="1200">
          <a:solidFill>
            <a:schemeClr val="tx1"/>
          </a:solidFill>
          <a:latin typeface="+mn-lt"/>
          <a:ea typeface="+mn-ea"/>
          <a:cs typeface="+mn-cs"/>
        </a:defRPr>
      </a:lvl4pPr>
      <a:lvl5pPr marL="895575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783" kern="1200">
          <a:solidFill>
            <a:schemeClr val="tx1"/>
          </a:solidFill>
          <a:latin typeface="+mn-lt"/>
          <a:ea typeface="+mn-ea"/>
          <a:cs typeface="+mn-cs"/>
        </a:defRPr>
      </a:lvl5pPr>
      <a:lvl6pPr marL="1094594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783" kern="1200">
          <a:solidFill>
            <a:schemeClr val="tx1"/>
          </a:solidFill>
          <a:latin typeface="+mn-lt"/>
          <a:ea typeface="+mn-ea"/>
          <a:cs typeface="+mn-cs"/>
        </a:defRPr>
      </a:lvl6pPr>
      <a:lvl7pPr marL="1293611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783" kern="1200">
          <a:solidFill>
            <a:schemeClr val="tx1"/>
          </a:solidFill>
          <a:latin typeface="+mn-lt"/>
          <a:ea typeface="+mn-ea"/>
          <a:cs typeface="+mn-cs"/>
        </a:defRPr>
      </a:lvl7pPr>
      <a:lvl8pPr marL="1492627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783" kern="1200">
          <a:solidFill>
            <a:schemeClr val="tx1"/>
          </a:solidFill>
          <a:latin typeface="+mn-lt"/>
          <a:ea typeface="+mn-ea"/>
          <a:cs typeface="+mn-cs"/>
        </a:defRPr>
      </a:lvl8pPr>
      <a:lvl9pPr marL="1691643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78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1pPr>
      <a:lvl2pPr marL="199016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2pPr>
      <a:lvl3pPr marL="398033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3pPr>
      <a:lvl4pPr marL="597049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4pPr>
      <a:lvl5pPr marL="796068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5pPr>
      <a:lvl6pPr marL="995085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6pPr>
      <a:lvl7pPr marL="1194101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7pPr>
      <a:lvl8pPr marL="1393117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8pPr>
      <a:lvl9pPr marL="1592134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44792C19-9357-2D79-1D80-453B6882E897}"/>
              </a:ext>
            </a:extLst>
          </p:cNvPr>
          <p:cNvSpPr txBox="1"/>
          <p:nvPr/>
        </p:nvSpPr>
        <p:spPr>
          <a:xfrm>
            <a:off x="266331" y="959086"/>
            <a:ext cx="5776782" cy="263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Supplementary Videos S1-S7. Modulation of Bevacizumab on effects of VEGF and cytokine on dynamic changes in the proliferation of PBMCs (Donor 1) in co-culture with HUVECs over 3-day time course.</a:t>
            </a:r>
          </a:p>
          <a:p>
            <a:endParaRPr lang="en-GB" sz="1100" b="1" dirty="0"/>
          </a:p>
          <a:p>
            <a:r>
              <a:rPr lang="en-GB" sz="1100" dirty="0"/>
              <a:t>Video S1: Representative real-time proliferation of untreated PBMCs in co-culture with HUVECs over 3-day time course.</a:t>
            </a:r>
          </a:p>
          <a:p>
            <a:endParaRPr lang="en-GB" sz="1100" dirty="0"/>
          </a:p>
          <a:p>
            <a:r>
              <a:rPr lang="en-GB" sz="1100" dirty="0"/>
              <a:t>Videos S2-S3: Representative real-time proliferation of VEGF-treated PBMCs in co-culture with HUVECs in the absence or presence of Bevacizumab over 3-day time course.</a:t>
            </a:r>
          </a:p>
          <a:p>
            <a:endParaRPr lang="en-GB" sz="1100" dirty="0"/>
          </a:p>
          <a:p>
            <a:r>
              <a:rPr lang="en-GB" sz="1100" dirty="0"/>
              <a:t>Videos S4-S5: Representative real-time proliferation of TNF-α-treated PBMCs in co-culture with HUVECs in the absence or presence of Bevacizumab over 3-day time course.</a:t>
            </a:r>
          </a:p>
          <a:p>
            <a:endParaRPr lang="en-GB" sz="1100" dirty="0"/>
          </a:p>
          <a:p>
            <a:r>
              <a:rPr lang="en-GB" sz="1100" dirty="0"/>
              <a:t>Videos S6-S7: Representative real-time proliferation of IFN-</a:t>
            </a:r>
            <a:r>
              <a:rPr lang="en-GB" sz="1100" dirty="0">
                <a:sym typeface="Symbol" panose="05050102010706020507" pitchFamily="18" charset="2"/>
              </a:rPr>
              <a:t> </a:t>
            </a:r>
            <a:r>
              <a:rPr lang="en-GB" sz="1100" dirty="0"/>
              <a:t>-treated PBMCs in co-culture with HUVECs in the absence or presence of Bevacizumab over 3-day time course.</a:t>
            </a:r>
          </a:p>
        </p:txBody>
      </p:sp>
    </p:spTree>
    <p:extLst>
      <p:ext uri="{BB962C8B-B14F-4D97-AF65-F5344CB8AC3E}">
        <p14:creationId xmlns:p14="http://schemas.microsoft.com/office/powerpoint/2010/main" val="1078735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ustom 1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09FD1574-6B76-478D-B748-39E12DFC4B80}" vid="{C2C441BF-D134-4CB8-9922-908F33263704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A80B22A7C471842A7E58BADDE5E7A4B" ma:contentTypeVersion="12" ma:contentTypeDescription="Create a new document." ma:contentTypeScope="" ma:versionID="a8922906f400981c30bd2b2c23dc7502">
  <xsd:schema xmlns:xsd="http://www.w3.org/2001/XMLSchema" xmlns:xs="http://www.w3.org/2001/XMLSchema" xmlns:p="http://schemas.microsoft.com/office/2006/metadata/properties" xmlns:ns3="82ae39a7-1d5a-4dd6-b249-0e57218a6f1e" xmlns:ns4="b447599a-0d05-4d9f-b452-27dc0079e13d" targetNamespace="http://schemas.microsoft.com/office/2006/metadata/properties" ma:root="true" ma:fieldsID="f72e49fa81869abe19777fc61a951712" ns3:_="" ns4:_="">
    <xsd:import namespace="82ae39a7-1d5a-4dd6-b249-0e57218a6f1e"/>
    <xsd:import namespace="b447599a-0d05-4d9f-b452-27dc0079e13d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DateTaken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ServiceAutoKeyPoints" minOccurs="0"/>
                <xsd:element ref="ns4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2ae39a7-1d5a-4dd6-b249-0e57218a6f1e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447599a-0d05-4d9f-b452-27dc0079e13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36FA4B3-C7F5-4DF8-A64D-90F3CB4AD70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2ae39a7-1d5a-4dd6-b249-0e57218a6f1e"/>
    <ds:schemaRef ds:uri="b447599a-0d05-4d9f-b452-27dc0079e13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62D5DDB-70A8-4BC7-8D97-DEA9CB9A4CDE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7D620F40-60E9-43D1-85CE-035C8AE20AC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9689</TotalTime>
  <Words>130</Words>
  <Application>Microsoft Office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vathy  Harikumar</dc:creator>
  <cp:lastModifiedBy>Haiyan Jia</cp:lastModifiedBy>
  <cp:revision>141</cp:revision>
  <dcterms:created xsi:type="dcterms:W3CDTF">2020-11-26T13:26:21Z</dcterms:created>
  <dcterms:modified xsi:type="dcterms:W3CDTF">2025-06-05T10:38:18Z</dcterms:modified>
</cp:coreProperties>
</file>